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7920038" cy="93599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5" d="100"/>
          <a:sy n="95" d="100"/>
        </p:scale>
        <p:origin x="1488" y="-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Arbeit\Publikationen\2024%20Arabidopsis%20arenosa\new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7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dPt>
            <c:idx val="0"/>
            <c:marker>
              <c:symbol val="circle"/>
              <c:size val="7"/>
              <c:spPr>
                <a:solidFill>
                  <a:srgbClr val="C00000"/>
                </a:solidFill>
                <a:ln w="9525">
                  <a:solidFill>
                    <a:srgbClr val="C00000"/>
                  </a:solidFill>
                </a:ln>
                <a:effectLst/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A618-4CAA-8943-5D988B9292FD}"/>
              </c:ext>
            </c:extLst>
          </c:dPt>
          <c:dPt>
            <c:idx val="1"/>
            <c:marker>
              <c:symbol val="circle"/>
              <c:size val="7"/>
              <c:spPr>
                <a:solidFill>
                  <a:srgbClr val="C00000"/>
                </a:solidFill>
                <a:ln w="9525">
                  <a:solidFill>
                    <a:srgbClr val="C00000"/>
                  </a:solidFill>
                </a:ln>
                <a:effectLst/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A618-4CAA-8943-5D988B9292FD}"/>
              </c:ext>
            </c:extLst>
          </c:dPt>
          <c:dPt>
            <c:idx val="27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A618-4CAA-8943-5D988B9292FD}"/>
              </c:ext>
            </c:extLst>
          </c:dPt>
          <c:dPt>
            <c:idx val="28"/>
            <c:marker>
              <c:symbol val="circle"/>
              <c:size val="7"/>
              <c:spPr>
                <a:solidFill>
                  <a:srgbClr val="002060"/>
                </a:solidFill>
                <a:ln w="9525">
                  <a:solidFill>
                    <a:srgbClr val="002060"/>
                  </a:solidFill>
                </a:ln>
                <a:effectLst/>
              </c:spPr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3-A618-4CAA-8943-5D988B9292FD}"/>
              </c:ext>
            </c:extLst>
          </c:dPt>
          <c:cat>
            <c:strRef>
              <c:f>Tabelle2!$C$2:$C$31</c:f>
              <c:strCache>
                <c:ptCount val="29"/>
                <c:pt idx="1">
                  <c:v>N3151</c:v>
                </c:pt>
                <c:pt idx="3">
                  <c:v>1</c:v>
                </c:pt>
                <c:pt idx="4">
                  <c:v>3</c:v>
                </c:pt>
                <c:pt idx="5">
                  <c:v>4</c:v>
                </c:pt>
                <c:pt idx="6">
                  <c:v>5</c:v>
                </c:pt>
                <c:pt idx="7">
                  <c:v>7</c:v>
                </c:pt>
                <c:pt idx="8">
                  <c:v>8</c:v>
                </c:pt>
                <c:pt idx="9">
                  <c:v>11</c:v>
                </c:pt>
                <c:pt idx="10">
                  <c:v>12</c:v>
                </c:pt>
                <c:pt idx="11">
                  <c:v>13</c:v>
                </c:pt>
                <c:pt idx="12">
                  <c:v>14</c:v>
                </c:pt>
                <c:pt idx="13">
                  <c:v>15</c:v>
                </c:pt>
                <c:pt idx="14">
                  <c:v>16</c:v>
                </c:pt>
                <c:pt idx="15">
                  <c:v>17</c:v>
                </c:pt>
                <c:pt idx="16">
                  <c:v>19</c:v>
                </c:pt>
                <c:pt idx="17">
                  <c:v>20</c:v>
                </c:pt>
                <c:pt idx="18">
                  <c:v>21</c:v>
                </c:pt>
                <c:pt idx="19">
                  <c:v>22</c:v>
                </c:pt>
                <c:pt idx="20">
                  <c:v>23</c:v>
                </c:pt>
                <c:pt idx="21">
                  <c:v>24</c:v>
                </c:pt>
                <c:pt idx="22">
                  <c:v>25</c:v>
                </c:pt>
                <c:pt idx="23">
                  <c:v>26</c:v>
                </c:pt>
                <c:pt idx="24">
                  <c:v>27</c:v>
                </c:pt>
                <c:pt idx="25">
                  <c:v>28</c:v>
                </c:pt>
                <c:pt idx="26">
                  <c:v>29</c:v>
                </c:pt>
                <c:pt idx="28">
                  <c:v>A. arenosa</c:v>
                </c:pt>
              </c:strCache>
            </c:strRef>
          </c:cat>
          <c:val>
            <c:numRef>
              <c:f>Tabelle2!$D$2:$D$31</c:f>
              <c:numCache>
                <c:formatCode>0.000</c:formatCode>
                <c:ptCount val="30"/>
                <c:pt idx="1">
                  <c:v>0.68289395945881004</c:v>
                </c:pt>
                <c:pt idx="3">
                  <c:v>0.73654559923896068</c:v>
                </c:pt>
                <c:pt idx="4">
                  <c:v>0.72361721268107504</c:v>
                </c:pt>
                <c:pt idx="5">
                  <c:v>0.74550932751727661</c:v>
                </c:pt>
                <c:pt idx="6">
                  <c:v>0.78578298605248054</c:v>
                </c:pt>
                <c:pt idx="7">
                  <c:v>0.76590220262567321</c:v>
                </c:pt>
                <c:pt idx="8">
                  <c:v>0.73970716312202478</c:v>
                </c:pt>
                <c:pt idx="9">
                  <c:v>0.77826328676211431</c:v>
                </c:pt>
                <c:pt idx="10">
                  <c:v>0.76976253261700334</c:v>
                </c:pt>
                <c:pt idx="11">
                  <c:v>0.75438807737860258</c:v>
                </c:pt>
                <c:pt idx="12">
                  <c:v>0.74923965710026097</c:v>
                </c:pt>
                <c:pt idx="13">
                  <c:v>0.71493539261411432</c:v>
                </c:pt>
                <c:pt idx="14">
                  <c:v>0.73763554820697763</c:v>
                </c:pt>
                <c:pt idx="15">
                  <c:v>0.74966752007856063</c:v>
                </c:pt>
                <c:pt idx="16">
                  <c:v>0.75261916291940512</c:v>
                </c:pt>
                <c:pt idx="17">
                  <c:v>0.79106417404407081</c:v>
                </c:pt>
                <c:pt idx="18">
                  <c:v>0.74433255269320853</c:v>
                </c:pt>
                <c:pt idx="19">
                  <c:v>0.72107911457265839</c:v>
                </c:pt>
                <c:pt idx="20">
                  <c:v>0.75005338443638359</c:v>
                </c:pt>
                <c:pt idx="21">
                  <c:v>0.74865087409277209</c:v>
                </c:pt>
                <c:pt idx="22">
                  <c:v>0.66189014737960683</c:v>
                </c:pt>
                <c:pt idx="23">
                  <c:v>0.70773317801791091</c:v>
                </c:pt>
                <c:pt idx="24">
                  <c:v>0.69345122225778599</c:v>
                </c:pt>
                <c:pt idx="25">
                  <c:v>0.70687882913546629</c:v>
                </c:pt>
                <c:pt idx="26">
                  <c:v>0.71314824035917002</c:v>
                </c:pt>
                <c:pt idx="28">
                  <c:v>0.8252625464469308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A618-4CAA-8943-5D988B9292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355155824"/>
        <c:axId val="-355153648"/>
      </c:lineChart>
      <c:catAx>
        <c:axId val="-3551558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5153648"/>
        <c:crosses val="autoZero"/>
        <c:auto val="1"/>
        <c:lblAlgn val="ctr"/>
        <c:lblOffset val="100"/>
        <c:noMultiLvlLbl val="0"/>
      </c:catAx>
      <c:valAx>
        <c:axId val="-355153648"/>
        <c:scaling>
          <c:orientation val="minMax"/>
          <c:max val="0.85000000000000009"/>
          <c:min val="0.65000000000000013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ysDot"/>
              <a:round/>
            </a:ln>
            <a:effectLst/>
          </c:spPr>
        </c:majorGridlines>
        <c:numFmt formatCode="#,##0.00" sourceLinked="0"/>
        <c:majorTickMark val="none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355155824"/>
        <c:crosses val="autoZero"/>
        <c:crossBetween val="between"/>
        <c:majorUnit val="5.000000000000001E-2"/>
        <c:minorUnit val="5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531818"/>
            <a:ext cx="6732032" cy="3258632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4916115"/>
            <a:ext cx="5940029" cy="2259809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295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370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498328"/>
            <a:ext cx="1707758" cy="793208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498328"/>
            <a:ext cx="5024274" cy="793208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583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3654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2333478"/>
            <a:ext cx="6831033" cy="3893458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6263769"/>
            <a:ext cx="6831033" cy="2047477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800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2491640"/>
            <a:ext cx="3366016" cy="593877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2491640"/>
            <a:ext cx="3366016" cy="593877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305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98330"/>
            <a:ext cx="6831033" cy="180914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2294476"/>
            <a:ext cx="3350547" cy="1124487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3418964"/>
            <a:ext cx="3350547" cy="502878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2294476"/>
            <a:ext cx="3367048" cy="1124487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3418964"/>
            <a:ext cx="3367048" cy="502878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740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977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10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23993"/>
            <a:ext cx="2554418" cy="2183977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1347654"/>
            <a:ext cx="4009519" cy="6651596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807970"/>
            <a:ext cx="2554418" cy="5202112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8278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623993"/>
            <a:ext cx="2554418" cy="2183977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1347654"/>
            <a:ext cx="4009519" cy="6651596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807970"/>
            <a:ext cx="2554418" cy="5202112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140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498330"/>
            <a:ext cx="6831033" cy="1809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2491640"/>
            <a:ext cx="6831033" cy="59387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8675243"/>
            <a:ext cx="1782009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56FCA3-90A7-47EA-9BF0-F654011C45A6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8675243"/>
            <a:ext cx="2673013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8675243"/>
            <a:ext cx="1782009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9BFFC-BF32-4E19-B79C-C2BCF07F93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220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565258" y="-166250"/>
            <a:ext cx="8235486" cy="9411465"/>
            <a:chOff x="-565258" y="-166250"/>
            <a:chExt cx="8235486" cy="9411465"/>
          </a:xfrm>
        </p:grpSpPr>
        <p:grpSp>
          <p:nvGrpSpPr>
            <p:cNvPr id="98" name="Group 97"/>
            <p:cNvGrpSpPr/>
            <p:nvPr/>
          </p:nvGrpSpPr>
          <p:grpSpPr>
            <a:xfrm>
              <a:off x="-565258" y="-166250"/>
              <a:ext cx="8235486" cy="9411465"/>
              <a:chOff x="-565258" y="-166250"/>
              <a:chExt cx="8235486" cy="9411465"/>
            </a:xfrm>
          </p:grpSpPr>
          <p:sp>
            <p:nvSpPr>
              <p:cNvPr id="51" name="Textfeld 1"/>
              <p:cNvSpPr txBox="1"/>
              <p:nvPr/>
            </p:nvSpPr>
            <p:spPr>
              <a:xfrm>
                <a:off x="6321782" y="8937438"/>
                <a:ext cx="134844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ppl</a:t>
                </a: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igure</a:t>
                </a: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3</a:t>
                </a:r>
              </a:p>
            </p:txBody>
          </p:sp>
          <p:sp>
            <p:nvSpPr>
              <p:cNvPr id="52" name="Rectangle 31"/>
              <p:cNvSpPr>
                <a:spLocks noChangeArrowheads="1"/>
              </p:cNvSpPr>
              <p:nvPr/>
            </p:nvSpPr>
            <p:spPr bwMode="auto">
              <a:xfrm>
                <a:off x="-565258" y="-166250"/>
                <a:ext cx="7561263" cy="4572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endParaRPr lang="de-DE"/>
              </a:p>
            </p:txBody>
          </p:sp>
          <p:sp>
            <p:nvSpPr>
              <p:cNvPr id="53" name="Rectangle 32"/>
              <p:cNvSpPr>
                <a:spLocks noChangeArrowheads="1"/>
              </p:cNvSpPr>
              <p:nvPr/>
            </p:nvSpPr>
            <p:spPr bwMode="auto">
              <a:xfrm>
                <a:off x="155352" y="290950"/>
                <a:ext cx="5868000" cy="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non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de-DE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a)</a:t>
                </a:r>
                <a:endParaRPr kumimoji="0" lang="de-DE" altLang="de-DE" sz="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de-DE" altLang="de-DE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pic>
            <p:nvPicPr>
              <p:cNvPr id="54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986" r="-813"/>
              <a:stretch>
                <a:fillRect/>
              </a:stretch>
            </p:blipFill>
            <p:spPr bwMode="auto">
              <a:xfrm>
                <a:off x="834362" y="4259480"/>
                <a:ext cx="5120248" cy="467795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5" name="Rectangle 54"/>
              <p:cNvSpPr>
                <a:spLocks noChangeArrowheads="1"/>
              </p:cNvSpPr>
              <p:nvPr/>
            </p:nvSpPr>
            <p:spPr bwMode="auto">
              <a:xfrm>
                <a:off x="155352" y="4259480"/>
                <a:ext cx="6462041" cy="27699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de-DE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b)</a:t>
                </a:r>
                <a:endParaRPr kumimoji="0" lang="en-US" altLang="de-DE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6" name="Rechteck 37"/>
              <p:cNvSpPr/>
              <p:nvPr/>
            </p:nvSpPr>
            <p:spPr>
              <a:xfrm>
                <a:off x="840461" y="1328180"/>
                <a:ext cx="4988257" cy="580030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cxnSp>
            <p:nvCxnSpPr>
              <p:cNvPr id="57" name="Gerader Verbinder 38"/>
              <p:cNvCxnSpPr/>
              <p:nvPr/>
            </p:nvCxnSpPr>
            <p:spPr>
              <a:xfrm>
                <a:off x="840461" y="1618195"/>
                <a:ext cx="4987130" cy="0"/>
              </a:xfrm>
              <a:prstGeom prst="line">
                <a:avLst/>
              </a:prstGeom>
              <a:ln>
                <a:solidFill>
                  <a:srgbClr val="E46C0A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aphicFrame>
            <p:nvGraphicFramePr>
              <p:cNvPr id="58" name="Diagramm 3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06779638"/>
                  </p:ext>
                </p:extLst>
              </p:nvPr>
            </p:nvGraphicFramePr>
            <p:xfrm>
              <a:off x="455407" y="256097"/>
              <a:ext cx="5555064" cy="333303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59" name="Rechteck 40"/>
              <p:cNvSpPr/>
              <p:nvPr/>
            </p:nvSpPr>
            <p:spPr>
              <a:xfrm>
                <a:off x="455407" y="256097"/>
                <a:ext cx="331057" cy="283768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60" name="Textfeld 41"/>
              <p:cNvSpPr txBox="1"/>
              <p:nvPr/>
            </p:nvSpPr>
            <p:spPr>
              <a:xfrm rot="16200000">
                <a:off x="-392211" y="1542852"/>
                <a:ext cx="136928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NA </a:t>
                </a:r>
                <a:r>
                  <a:rPr lang="de-DE" sz="1000" dirty="0" err="1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ntent</a:t>
                </a:r>
                <a:r>
                  <a:rPr lang="de-DE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de-DE" sz="1000" dirty="0" err="1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lang="de-DE" sz="10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2C)</a:t>
                </a:r>
              </a:p>
            </p:txBody>
          </p:sp>
          <p:sp>
            <p:nvSpPr>
              <p:cNvPr id="61" name="Textfeld 42"/>
              <p:cNvSpPr txBox="1"/>
              <p:nvPr/>
            </p:nvSpPr>
            <p:spPr>
              <a:xfrm>
                <a:off x="5771934" y="1505858"/>
                <a:ext cx="505267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solidFill>
                      <a:srgbClr val="E46C0A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754 </a:t>
                </a:r>
              </a:p>
            </p:txBody>
          </p:sp>
          <p:sp>
            <p:nvSpPr>
              <p:cNvPr id="62" name="Textfeld 43"/>
              <p:cNvSpPr txBox="1"/>
              <p:nvPr/>
            </p:nvSpPr>
            <p:spPr>
              <a:xfrm>
                <a:off x="5376136" y="459169"/>
                <a:ext cx="4732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825</a:t>
                </a:r>
              </a:p>
            </p:txBody>
          </p:sp>
          <p:sp>
            <p:nvSpPr>
              <p:cNvPr id="63" name="Textfeld 44"/>
              <p:cNvSpPr txBox="1"/>
              <p:nvPr/>
            </p:nvSpPr>
            <p:spPr>
              <a:xfrm>
                <a:off x="858489" y="2546389"/>
                <a:ext cx="4732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683</a:t>
                </a:r>
              </a:p>
            </p:txBody>
          </p:sp>
          <p:sp>
            <p:nvSpPr>
              <p:cNvPr id="64" name="Textfeld 45"/>
              <p:cNvSpPr txBox="1"/>
              <p:nvPr/>
            </p:nvSpPr>
            <p:spPr>
              <a:xfrm>
                <a:off x="439464" y="279950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85</a:t>
                </a:r>
              </a:p>
            </p:txBody>
          </p:sp>
          <p:sp>
            <p:nvSpPr>
              <p:cNvPr id="65" name="Textfeld 46"/>
              <p:cNvSpPr txBox="1"/>
              <p:nvPr/>
            </p:nvSpPr>
            <p:spPr>
              <a:xfrm>
                <a:off x="439464" y="905661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80</a:t>
                </a:r>
              </a:p>
            </p:txBody>
          </p:sp>
          <p:sp>
            <p:nvSpPr>
              <p:cNvPr id="66" name="Textfeld 47"/>
              <p:cNvSpPr txBox="1"/>
              <p:nvPr/>
            </p:nvSpPr>
            <p:spPr>
              <a:xfrm>
                <a:off x="439464" y="1545613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75</a:t>
                </a:r>
              </a:p>
            </p:txBody>
          </p:sp>
          <p:sp>
            <p:nvSpPr>
              <p:cNvPr id="67" name="Textfeld 48"/>
              <p:cNvSpPr txBox="1"/>
              <p:nvPr/>
            </p:nvSpPr>
            <p:spPr>
              <a:xfrm>
                <a:off x="439464" y="2179600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70</a:t>
                </a:r>
              </a:p>
            </p:txBody>
          </p:sp>
          <p:sp>
            <p:nvSpPr>
              <p:cNvPr id="68" name="Textfeld 49"/>
              <p:cNvSpPr txBox="1"/>
              <p:nvPr/>
            </p:nvSpPr>
            <p:spPr>
              <a:xfrm>
                <a:off x="439464" y="2814731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.65</a:t>
                </a:r>
              </a:p>
            </p:txBody>
          </p:sp>
          <p:sp>
            <p:nvSpPr>
              <p:cNvPr id="69" name="Rechteck 50"/>
              <p:cNvSpPr/>
              <p:nvPr/>
            </p:nvSpPr>
            <p:spPr>
              <a:xfrm>
                <a:off x="914188" y="2980294"/>
                <a:ext cx="4857746" cy="6189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70" name="Textfeld 51"/>
              <p:cNvSpPr txBox="1"/>
              <p:nvPr/>
            </p:nvSpPr>
            <p:spPr>
              <a:xfrm rot="18900000">
                <a:off x="213092" y="3288430"/>
                <a:ext cx="11288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de-DE" sz="1000" b="1" dirty="0" err="1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aliana</a:t>
                </a:r>
                <a:r>
                  <a:rPr lang="de-DE" sz="1000" b="1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4x)</a:t>
                </a:r>
              </a:p>
            </p:txBody>
          </p:sp>
          <p:sp>
            <p:nvSpPr>
              <p:cNvPr id="71" name="Textfeld 52"/>
              <p:cNvSpPr txBox="1"/>
              <p:nvPr/>
            </p:nvSpPr>
            <p:spPr>
              <a:xfrm rot="18900000">
                <a:off x="1295005" y="2984980"/>
                <a:ext cx="2487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72" name="Textfeld 53"/>
              <p:cNvSpPr txBox="1"/>
              <p:nvPr/>
            </p:nvSpPr>
            <p:spPr>
              <a:xfrm rot="18900000">
                <a:off x="1370278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73" name="Textfeld 54"/>
              <p:cNvSpPr txBox="1"/>
              <p:nvPr/>
            </p:nvSpPr>
            <p:spPr>
              <a:xfrm rot="18900000">
                <a:off x="1538470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74" name="Textfeld 55"/>
              <p:cNvSpPr txBox="1"/>
              <p:nvPr/>
            </p:nvSpPr>
            <p:spPr>
              <a:xfrm rot="18900000">
                <a:off x="1699411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75" name="Textfeld 56"/>
              <p:cNvSpPr txBox="1"/>
              <p:nvPr/>
            </p:nvSpPr>
            <p:spPr>
              <a:xfrm rot="18900000">
                <a:off x="1875554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76" name="Textfeld 57"/>
              <p:cNvSpPr txBox="1"/>
              <p:nvPr/>
            </p:nvSpPr>
            <p:spPr>
              <a:xfrm rot="18900000">
                <a:off x="2036082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77" name="Textfeld 58"/>
              <p:cNvSpPr txBox="1"/>
              <p:nvPr/>
            </p:nvSpPr>
            <p:spPr>
              <a:xfrm rot="18900000">
                <a:off x="2212038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78" name="Textfeld 59"/>
              <p:cNvSpPr txBox="1"/>
              <p:nvPr/>
            </p:nvSpPr>
            <p:spPr>
              <a:xfrm rot="18900000">
                <a:off x="2379089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  <p:sp>
            <p:nvSpPr>
              <p:cNvPr id="79" name="Textfeld 60"/>
              <p:cNvSpPr txBox="1"/>
              <p:nvPr/>
            </p:nvSpPr>
            <p:spPr>
              <a:xfrm rot="18900000">
                <a:off x="2546937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</a:p>
            </p:txBody>
          </p:sp>
          <p:sp>
            <p:nvSpPr>
              <p:cNvPr id="80" name="Textfeld 61"/>
              <p:cNvSpPr txBox="1"/>
              <p:nvPr/>
            </p:nvSpPr>
            <p:spPr>
              <a:xfrm rot="18900000">
                <a:off x="2708542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</a:p>
            </p:txBody>
          </p:sp>
          <p:sp>
            <p:nvSpPr>
              <p:cNvPr id="81" name="Textfeld 62"/>
              <p:cNvSpPr txBox="1"/>
              <p:nvPr/>
            </p:nvSpPr>
            <p:spPr>
              <a:xfrm rot="18900000">
                <a:off x="2877016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82" name="Textfeld 63"/>
              <p:cNvSpPr txBox="1"/>
              <p:nvPr/>
            </p:nvSpPr>
            <p:spPr>
              <a:xfrm rot="18900000">
                <a:off x="3053101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</a:p>
            </p:txBody>
          </p:sp>
          <p:sp>
            <p:nvSpPr>
              <p:cNvPr id="83" name="Textfeld 64"/>
              <p:cNvSpPr txBox="1"/>
              <p:nvPr/>
            </p:nvSpPr>
            <p:spPr>
              <a:xfrm rot="18900000">
                <a:off x="3213371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</a:p>
            </p:txBody>
          </p:sp>
          <p:sp>
            <p:nvSpPr>
              <p:cNvPr id="84" name="Textfeld 65"/>
              <p:cNvSpPr txBox="1"/>
              <p:nvPr/>
            </p:nvSpPr>
            <p:spPr>
              <a:xfrm rot="18900000">
                <a:off x="3380638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</a:p>
            </p:txBody>
          </p:sp>
          <p:sp>
            <p:nvSpPr>
              <p:cNvPr id="85" name="Textfeld 66"/>
              <p:cNvSpPr txBox="1"/>
              <p:nvPr/>
            </p:nvSpPr>
            <p:spPr>
              <a:xfrm rot="18900000">
                <a:off x="3557136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86" name="Textfeld 67"/>
              <p:cNvSpPr txBox="1"/>
              <p:nvPr/>
            </p:nvSpPr>
            <p:spPr>
              <a:xfrm rot="18900000">
                <a:off x="3725049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</a:p>
            </p:txBody>
          </p:sp>
          <p:sp>
            <p:nvSpPr>
              <p:cNvPr id="87" name="Textfeld 68"/>
              <p:cNvSpPr txBox="1"/>
              <p:nvPr/>
            </p:nvSpPr>
            <p:spPr>
              <a:xfrm rot="18900000">
                <a:off x="3885386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</p:txBody>
          </p:sp>
          <p:sp>
            <p:nvSpPr>
              <p:cNvPr id="88" name="Textfeld 69"/>
              <p:cNvSpPr txBox="1"/>
              <p:nvPr/>
            </p:nvSpPr>
            <p:spPr>
              <a:xfrm rot="18900000">
                <a:off x="4053299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3</a:t>
                </a:r>
              </a:p>
            </p:txBody>
          </p:sp>
          <p:sp>
            <p:nvSpPr>
              <p:cNvPr id="89" name="Textfeld 70"/>
              <p:cNvSpPr txBox="1"/>
              <p:nvPr/>
            </p:nvSpPr>
            <p:spPr>
              <a:xfrm rot="18900000">
                <a:off x="4222436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</a:p>
            </p:txBody>
          </p:sp>
          <p:sp>
            <p:nvSpPr>
              <p:cNvPr id="90" name="Textfeld 71"/>
              <p:cNvSpPr txBox="1"/>
              <p:nvPr/>
            </p:nvSpPr>
            <p:spPr>
              <a:xfrm rot="18900000">
                <a:off x="4390818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</a:p>
            </p:txBody>
          </p:sp>
          <p:sp>
            <p:nvSpPr>
              <p:cNvPr id="91" name="Textfeld 72"/>
              <p:cNvSpPr txBox="1"/>
              <p:nvPr/>
            </p:nvSpPr>
            <p:spPr>
              <a:xfrm rot="18900000">
                <a:off x="4559714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</a:p>
            </p:txBody>
          </p:sp>
          <p:sp>
            <p:nvSpPr>
              <p:cNvPr id="92" name="Textfeld 73"/>
              <p:cNvSpPr txBox="1"/>
              <p:nvPr/>
            </p:nvSpPr>
            <p:spPr>
              <a:xfrm rot="18900000">
                <a:off x="4720170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</p:txBody>
          </p:sp>
          <p:sp>
            <p:nvSpPr>
              <p:cNvPr id="93" name="Textfeld 74"/>
              <p:cNvSpPr txBox="1"/>
              <p:nvPr/>
            </p:nvSpPr>
            <p:spPr>
              <a:xfrm rot="18900000">
                <a:off x="4889628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8</a:t>
                </a:r>
              </a:p>
            </p:txBody>
          </p:sp>
          <p:sp>
            <p:nvSpPr>
              <p:cNvPr id="94" name="Textfeld 75"/>
              <p:cNvSpPr txBox="1"/>
              <p:nvPr/>
            </p:nvSpPr>
            <p:spPr>
              <a:xfrm rot="18900000">
                <a:off x="5057930" y="3024300"/>
                <a:ext cx="36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90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9</a:t>
                </a:r>
              </a:p>
            </p:txBody>
          </p:sp>
          <p:sp>
            <p:nvSpPr>
              <p:cNvPr id="95" name="Textfeld 76"/>
              <p:cNvSpPr txBox="1"/>
              <p:nvPr/>
            </p:nvSpPr>
            <p:spPr>
              <a:xfrm rot="18900000">
                <a:off x="4672676" y="3306811"/>
                <a:ext cx="118082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00" b="1" i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de-DE" sz="1000" b="1" i="1" dirty="0" err="1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enosa</a:t>
                </a:r>
                <a:r>
                  <a:rPr lang="de-DE" sz="1000" b="1" i="1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4x)</a:t>
                </a:r>
              </a:p>
            </p:txBody>
          </p:sp>
          <p:cxnSp>
            <p:nvCxnSpPr>
              <p:cNvPr id="96" name="Gerader Verbinder 77"/>
              <p:cNvCxnSpPr/>
              <p:nvPr/>
            </p:nvCxnSpPr>
            <p:spPr>
              <a:xfrm>
                <a:off x="1374860" y="3255898"/>
                <a:ext cx="3944320" cy="0"/>
              </a:xfrm>
              <a:prstGeom prst="line">
                <a:avLst/>
              </a:prstGeom>
              <a:ln w="190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feld 78"/>
              <p:cNvSpPr txBox="1"/>
              <p:nvPr/>
            </p:nvSpPr>
            <p:spPr>
              <a:xfrm>
                <a:off x="2584880" y="3273500"/>
                <a:ext cx="162416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000" b="1" i="1" dirty="0" smtClean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thaliana x </a:t>
                </a:r>
                <a:r>
                  <a:rPr lang="de-DE" sz="1000" b="1" i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. </a:t>
                </a:r>
                <a:r>
                  <a:rPr lang="de-DE" sz="1000" b="1" i="1" dirty="0" err="1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enosa</a:t>
                </a:r>
                <a:endParaRPr lang="de-DE" sz="1000" b="1" i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1317375" y="7584184"/>
              <a:ext cx="238752" cy="187016"/>
            </a:xfrm>
            <a:custGeom>
              <a:avLst/>
              <a:gdLst>
                <a:gd name="connsiteX0" fmla="*/ 0 w 255198"/>
                <a:gd name="connsiteY0" fmla="*/ 0 h 246221"/>
                <a:gd name="connsiteX1" fmla="*/ 255198 w 255198"/>
                <a:gd name="connsiteY1" fmla="*/ 0 h 246221"/>
                <a:gd name="connsiteX2" fmla="*/ 255198 w 255198"/>
                <a:gd name="connsiteY2" fmla="*/ 246221 h 246221"/>
                <a:gd name="connsiteX3" fmla="*/ 0 w 255198"/>
                <a:gd name="connsiteY3" fmla="*/ 246221 h 246221"/>
                <a:gd name="connsiteX4" fmla="*/ 0 w 255198"/>
                <a:gd name="connsiteY4" fmla="*/ 0 h 246221"/>
                <a:gd name="connsiteX0" fmla="*/ 0 w 255198"/>
                <a:gd name="connsiteY0" fmla="*/ 0 h 246221"/>
                <a:gd name="connsiteX1" fmla="*/ 255198 w 255198"/>
                <a:gd name="connsiteY1" fmla="*/ 0 h 246221"/>
                <a:gd name="connsiteX2" fmla="*/ 255198 w 255198"/>
                <a:gd name="connsiteY2" fmla="*/ 246221 h 246221"/>
                <a:gd name="connsiteX3" fmla="*/ 0 w 255198"/>
                <a:gd name="connsiteY3" fmla="*/ 190304 h 246221"/>
                <a:gd name="connsiteX4" fmla="*/ 0 w 255198"/>
                <a:gd name="connsiteY4" fmla="*/ 0 h 246221"/>
                <a:gd name="connsiteX0" fmla="*/ 0 w 255198"/>
                <a:gd name="connsiteY0" fmla="*/ 0 h 193594"/>
                <a:gd name="connsiteX1" fmla="*/ 255198 w 255198"/>
                <a:gd name="connsiteY1" fmla="*/ 0 h 193594"/>
                <a:gd name="connsiteX2" fmla="*/ 248620 w 255198"/>
                <a:gd name="connsiteY2" fmla="*/ 193594 h 193594"/>
                <a:gd name="connsiteX3" fmla="*/ 0 w 255198"/>
                <a:gd name="connsiteY3" fmla="*/ 190304 h 193594"/>
                <a:gd name="connsiteX4" fmla="*/ 0 w 255198"/>
                <a:gd name="connsiteY4" fmla="*/ 0 h 193594"/>
                <a:gd name="connsiteX0" fmla="*/ 0 w 255198"/>
                <a:gd name="connsiteY0" fmla="*/ 0 h 193594"/>
                <a:gd name="connsiteX1" fmla="*/ 255198 w 255198"/>
                <a:gd name="connsiteY1" fmla="*/ 0 h 193594"/>
                <a:gd name="connsiteX2" fmla="*/ 248620 w 255198"/>
                <a:gd name="connsiteY2" fmla="*/ 193594 h 193594"/>
                <a:gd name="connsiteX3" fmla="*/ 9868 w 255198"/>
                <a:gd name="connsiteY3" fmla="*/ 173858 h 193594"/>
                <a:gd name="connsiteX4" fmla="*/ 0 w 255198"/>
                <a:gd name="connsiteY4" fmla="*/ 0 h 193594"/>
                <a:gd name="connsiteX0" fmla="*/ 0 w 255198"/>
                <a:gd name="connsiteY0" fmla="*/ 0 h 187016"/>
                <a:gd name="connsiteX1" fmla="*/ 255198 w 255198"/>
                <a:gd name="connsiteY1" fmla="*/ 0 h 187016"/>
                <a:gd name="connsiteX2" fmla="*/ 238752 w 255198"/>
                <a:gd name="connsiteY2" fmla="*/ 187016 h 187016"/>
                <a:gd name="connsiteX3" fmla="*/ 9868 w 255198"/>
                <a:gd name="connsiteY3" fmla="*/ 173858 h 187016"/>
                <a:gd name="connsiteX4" fmla="*/ 0 w 255198"/>
                <a:gd name="connsiteY4" fmla="*/ 0 h 187016"/>
                <a:gd name="connsiteX0" fmla="*/ 0 w 238752"/>
                <a:gd name="connsiteY0" fmla="*/ 0 h 187016"/>
                <a:gd name="connsiteX1" fmla="*/ 195992 w 238752"/>
                <a:gd name="connsiteY1" fmla="*/ 16446 h 187016"/>
                <a:gd name="connsiteX2" fmla="*/ 238752 w 238752"/>
                <a:gd name="connsiteY2" fmla="*/ 187016 h 187016"/>
                <a:gd name="connsiteX3" fmla="*/ 9868 w 238752"/>
                <a:gd name="connsiteY3" fmla="*/ 173858 h 187016"/>
                <a:gd name="connsiteX4" fmla="*/ 0 w 238752"/>
                <a:gd name="connsiteY4" fmla="*/ 0 h 1870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38752" h="187016">
                  <a:moveTo>
                    <a:pt x="0" y="0"/>
                  </a:moveTo>
                  <a:lnTo>
                    <a:pt x="195992" y="16446"/>
                  </a:lnTo>
                  <a:lnTo>
                    <a:pt x="238752" y="187016"/>
                  </a:lnTo>
                  <a:lnTo>
                    <a:pt x="9868" y="17385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74218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64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2</cp:revision>
  <dcterms:created xsi:type="dcterms:W3CDTF">2024-02-25T18:37:46Z</dcterms:created>
  <dcterms:modified xsi:type="dcterms:W3CDTF">2024-02-25T19:01:55Z</dcterms:modified>
</cp:coreProperties>
</file>